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756" y="57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A2F8C-49E2-4B66-9E6C-EF69B428CA8E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1A0A-FDEB-4807-B6D9-06161EE3FEC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6941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A2F8C-49E2-4B66-9E6C-EF69B428CA8E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1A0A-FDEB-4807-B6D9-06161EE3FEC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0645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A2F8C-49E2-4B66-9E6C-EF69B428CA8E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1A0A-FDEB-4807-B6D9-06161EE3FEC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4694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A2F8C-49E2-4B66-9E6C-EF69B428CA8E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1A0A-FDEB-4807-B6D9-06161EE3FEC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0897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A2F8C-49E2-4B66-9E6C-EF69B428CA8E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1A0A-FDEB-4807-B6D9-06161EE3FEC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3072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A2F8C-49E2-4B66-9E6C-EF69B428CA8E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1A0A-FDEB-4807-B6D9-06161EE3FEC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7215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A2F8C-49E2-4B66-9E6C-EF69B428CA8E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1A0A-FDEB-4807-B6D9-06161EE3FEC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6678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A2F8C-49E2-4B66-9E6C-EF69B428CA8E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1A0A-FDEB-4807-B6D9-06161EE3FEC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2377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A2F8C-49E2-4B66-9E6C-EF69B428CA8E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1A0A-FDEB-4807-B6D9-06161EE3FEC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76264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A2F8C-49E2-4B66-9E6C-EF69B428CA8E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1A0A-FDEB-4807-B6D9-06161EE3FEC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2677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A2F8C-49E2-4B66-9E6C-EF69B428CA8E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1A0A-FDEB-4807-B6D9-06161EE3FEC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7103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6A2F8C-49E2-4B66-9E6C-EF69B428CA8E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31A0A-FDEB-4807-B6D9-06161EE3FEC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7536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0382652"/>
              </p:ext>
            </p:extLst>
          </p:nvPr>
        </p:nvGraphicFramePr>
        <p:xfrm>
          <a:off x="971600" y="1484784"/>
          <a:ext cx="7056784" cy="420362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764196"/>
                <a:gridCol w="1764196"/>
                <a:gridCol w="1764196"/>
                <a:gridCol w="1764196"/>
              </a:tblGrid>
              <a:tr h="432048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dirty="0">
                          <a:effectLst/>
                        </a:rPr>
                        <a:t>Migrated </a:t>
                      </a:r>
                      <a:r>
                        <a:rPr lang="en-GB" sz="1400" u="none" strike="noStrike" dirty="0" smtClean="0">
                          <a:effectLst/>
                        </a:rPr>
                        <a:t>cells 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u="none" strike="noStrike" dirty="0" smtClean="0">
                          <a:effectLst/>
                        </a:rPr>
                        <a:t>Chemotactic index (number of migrating cells in treatment group/number of migrating cells in control group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51096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no treatment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rHDL on day 0-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rHDL on day 0-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rHDL on day 4-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9641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4.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9641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9641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9641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9641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4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9641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9641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9641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5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9641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9641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9641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6729915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</Words>
  <Application>Microsoft Office PowerPoint</Application>
  <PresentationFormat>Bildschirmpräsentation (4:3)</PresentationFormat>
  <Paragraphs>5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atherine</dc:creator>
  <cp:lastModifiedBy>Catherine</cp:lastModifiedBy>
  <cp:revision>1</cp:revision>
  <dcterms:created xsi:type="dcterms:W3CDTF">2016-10-28T18:52:06Z</dcterms:created>
  <dcterms:modified xsi:type="dcterms:W3CDTF">2016-10-28T18:55:34Z</dcterms:modified>
</cp:coreProperties>
</file>